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148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237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718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276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91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936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471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49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28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473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3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594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AE8C5-F5EB-4932-80FB-A206EF69477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E6CB7-6C23-4FAB-A284-5105ABDC38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034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184DE36-5AB7-35E8-C7AB-02C9AD053618}"/>
              </a:ext>
            </a:extLst>
          </p:cNvPr>
          <p:cNvGrpSpPr/>
          <p:nvPr/>
        </p:nvGrpSpPr>
        <p:grpSpPr>
          <a:xfrm>
            <a:off x="202797" y="759050"/>
            <a:ext cx="3493703" cy="2246746"/>
            <a:chOff x="201342" y="2474294"/>
            <a:chExt cx="3398950" cy="21608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A050B62-21C6-1750-270F-E2701F182E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5191" b="1"/>
            <a:stretch/>
          </p:blipFill>
          <p:spPr>
            <a:xfrm>
              <a:off x="201342" y="2653861"/>
              <a:ext cx="3384784" cy="1981233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DCC6EDFF-C49E-02CD-2EF8-D1F494974BCD}"/>
                </a:ext>
              </a:extLst>
            </p:cNvPr>
            <p:cNvGrpSpPr/>
            <p:nvPr/>
          </p:nvGrpSpPr>
          <p:grpSpPr>
            <a:xfrm>
              <a:off x="319596" y="2474294"/>
              <a:ext cx="3280696" cy="259002"/>
              <a:chOff x="319596" y="2474294"/>
              <a:chExt cx="3280696" cy="259002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EFF976D1-346C-CB4B-354F-080F1236C3C9}"/>
                  </a:ext>
                </a:extLst>
              </p:cNvPr>
              <p:cNvSpPr txBox="1"/>
              <p:nvPr/>
            </p:nvSpPr>
            <p:spPr>
              <a:xfrm>
                <a:off x="319596" y="2474294"/>
                <a:ext cx="998874" cy="2590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OV90 shneg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1749C171-C500-67BC-7C82-0E387E958794}"/>
                  </a:ext>
                </a:extLst>
              </p:cNvPr>
              <p:cNvSpPr txBox="1"/>
              <p:nvPr/>
            </p:nvSpPr>
            <p:spPr>
              <a:xfrm>
                <a:off x="1436240" y="2474294"/>
                <a:ext cx="998874" cy="2590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OV90 sh459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9ECC1F42-B432-5425-7EF4-114A8BFD6BC8}"/>
                  </a:ext>
                </a:extLst>
              </p:cNvPr>
              <p:cNvSpPr txBox="1"/>
              <p:nvPr/>
            </p:nvSpPr>
            <p:spPr>
              <a:xfrm>
                <a:off x="2502947" y="2474294"/>
                <a:ext cx="1097345" cy="2590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OV90 sh939</a:t>
                </a:r>
              </a:p>
            </p:txBody>
          </p:sp>
        </p:grpSp>
      </p:grpSp>
      <p:pic>
        <p:nvPicPr>
          <p:cNvPr id="8" name="Picture 7" descr="A picture containing silhouette, light, night sky&#10;&#10;Description automatically generated">
            <a:extLst>
              <a:ext uri="{FF2B5EF4-FFF2-40B4-BE49-F238E27FC236}">
                <a16:creationId xmlns:a16="http://schemas.microsoft.com/office/drawing/2014/main" id="{7E1FBC67-EB13-AF2B-0C1A-D4528E9770C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5127" y="3458484"/>
            <a:ext cx="1663005" cy="171819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8BD9D3F-4CAF-10AA-C657-D95BA2B7DEE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4560" y="3614049"/>
            <a:ext cx="4930567" cy="139809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B2353DA-40CF-F1E8-BC5D-4E76733684E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13769" y="784254"/>
            <a:ext cx="2375464" cy="228947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00D6E14-CAE5-C0FA-4998-281B31EA9B10}"/>
              </a:ext>
            </a:extLst>
          </p:cNvPr>
          <p:cNvSpPr txBox="1"/>
          <p:nvPr/>
        </p:nvSpPr>
        <p:spPr>
          <a:xfrm>
            <a:off x="5073857" y="3270134"/>
            <a:ext cx="40640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BA06D1B-69A4-A2DC-A2AF-2A008F8DA9DD}"/>
              </a:ext>
            </a:extLst>
          </p:cNvPr>
          <p:cNvSpPr txBox="1"/>
          <p:nvPr/>
        </p:nvSpPr>
        <p:spPr>
          <a:xfrm>
            <a:off x="-65979" y="8477"/>
            <a:ext cx="323327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94"/>
            <a:r>
              <a:rPr lang="en-US" sz="1401" dirty="0">
                <a:solidFill>
                  <a:prstClr val="black"/>
                </a:solidFill>
                <a:latin typeface="Calibri" panose="020F0502020204030204"/>
              </a:rPr>
              <a:t>Supplementary Figure 2, Harrington et a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87AF048-A2FE-6118-D350-498AF4F9CAA5}"/>
              </a:ext>
            </a:extLst>
          </p:cNvPr>
          <p:cNvSpPr txBox="1"/>
          <p:nvPr/>
        </p:nvSpPr>
        <p:spPr>
          <a:xfrm>
            <a:off x="61641" y="316382"/>
            <a:ext cx="406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681468D-3247-F1B7-1D2D-8AD1CE104CC4}"/>
              </a:ext>
            </a:extLst>
          </p:cNvPr>
          <p:cNvSpPr txBox="1"/>
          <p:nvPr/>
        </p:nvSpPr>
        <p:spPr>
          <a:xfrm>
            <a:off x="3913769" y="316382"/>
            <a:ext cx="406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05526D5-B7CB-5C40-47B2-2CA1F7C140E5}"/>
              </a:ext>
            </a:extLst>
          </p:cNvPr>
          <p:cNvSpPr txBox="1"/>
          <p:nvPr/>
        </p:nvSpPr>
        <p:spPr>
          <a:xfrm>
            <a:off x="92020" y="3269529"/>
            <a:ext cx="221554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5F6ED3E-7FD0-D390-92EC-2167932C220A}"/>
              </a:ext>
            </a:extLst>
          </p:cNvPr>
          <p:cNvSpPr txBox="1"/>
          <p:nvPr/>
        </p:nvSpPr>
        <p:spPr>
          <a:xfrm>
            <a:off x="264841" y="5376777"/>
            <a:ext cx="6126480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: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fects of UGDH knockdown in OV90 cells, and over-expression in ACI23 cells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A) Representative brightfield images of adherent cell culture morphology of OV90 control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neg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UGDH knockdown (sh459, sh939) cells and B) ACI23 control (VC) and UGDH-overexpressing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X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cells. Magnifications as indicated; scale bar is 100µm. C) Representative images of OV90 control cells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neg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UGDH silenced cells (sh459, 939) with immunofluorescent staining of E-cadherin (green), Vimentin (purple), and merged images with nuclear stain DAPI (blue) at 60x magnification, scale bar is 20µm. D) Ratio of E-cadherin: Vimentin intensity of immunofluorescent images. *p&lt;0.05, ***p&lt;0.001.</a:t>
            </a:r>
          </a:p>
        </p:txBody>
      </p:sp>
    </p:spTree>
    <p:extLst>
      <p:ext uri="{BB962C8B-B14F-4D97-AF65-F5344CB8AC3E}">
        <p14:creationId xmlns:p14="http://schemas.microsoft.com/office/powerpoint/2010/main" val="295563395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159</Words>
  <Application>Microsoft Office PowerPoint</Application>
  <PresentationFormat>Letter Paper (8.5x11 in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ington, Brittney (NIH/NCI) [F]</dc:creator>
  <cp:lastModifiedBy>Harrington, Brittney (NIH/NCI) [F]</cp:lastModifiedBy>
  <cp:revision>5</cp:revision>
  <cp:lastPrinted>2023-08-17T16:37:36Z</cp:lastPrinted>
  <dcterms:created xsi:type="dcterms:W3CDTF">2023-08-09T18:50:53Z</dcterms:created>
  <dcterms:modified xsi:type="dcterms:W3CDTF">2023-08-17T17:53:42Z</dcterms:modified>
</cp:coreProperties>
</file>